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6" r:id="rId2"/>
    <p:sldId id="277" r:id="rId3"/>
  </p:sldIdLst>
  <p:sldSz cx="9144000" cy="6858000" type="screen4x3"/>
  <p:notesSz cx="6805613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140" y="-72"/>
      </p:cViewPr>
      <p:guideLst>
        <p:guide orient="horz" pos="2160"/>
        <p:guide pos="2880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ley\Desktop\&#49328;&#49688;&#50976;%20revision\&#49328;&#49688;&#50976;%20&#45436;&#47928;%20&#45936;&#51060;&#53552;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shley\Desktop\&#49328;&#49688;&#50976;%20revision\&#49328;&#49688;&#50976;%20&#45436;&#47928;%20&#45936;&#51060;&#53552;.xlsx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shley\Desktop\&#49328;&#49688;&#50976;%20revision\&#49328;&#49688;&#50976;%20&#45436;&#47928;%20&#45936;&#51060;&#53552;.xlsx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ley\Desktop\&#49328;&#49688;&#50976;%20revision\&#49328;&#49688;&#50976;%20&#45436;&#47928;%20&#45936;&#51060;&#5355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984876543209989E-2"/>
          <c:y val="3.3120512820512822E-2"/>
          <c:w val="0.88936172839506178"/>
          <c:h val="0.8680085470085476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OD_H2O2!$AA$30:$AA$34</c:f>
                <c:numCache>
                  <c:formatCode>General</c:formatCode>
                  <c:ptCount val="5"/>
                  <c:pt idx="0">
                    <c:v>1.0350599681531889</c:v>
                  </c:pt>
                  <c:pt idx="1">
                    <c:v>0.2167223754585193</c:v>
                  </c:pt>
                  <c:pt idx="2">
                    <c:v>0.16605990719297831</c:v>
                  </c:pt>
                  <c:pt idx="3">
                    <c:v>0.69290919883754709</c:v>
                  </c:pt>
                  <c:pt idx="4">
                    <c:v>0.36095126287132429</c:v>
                  </c:pt>
                </c:numCache>
              </c:numRef>
            </c:plus>
            <c:minus>
              <c:numRef>
                <c:f>SOD_H2O2!$AA$30:$AA$34</c:f>
                <c:numCache>
                  <c:formatCode>General</c:formatCode>
                  <c:ptCount val="5"/>
                  <c:pt idx="0">
                    <c:v>1.0350599681531889</c:v>
                  </c:pt>
                  <c:pt idx="1">
                    <c:v>0.2167223754585193</c:v>
                  </c:pt>
                  <c:pt idx="2">
                    <c:v>0.16605990719297831</c:v>
                  </c:pt>
                  <c:pt idx="3">
                    <c:v>0.69290919883754709</c:v>
                  </c:pt>
                  <c:pt idx="4">
                    <c:v>0.36095126287132429</c:v>
                  </c:pt>
                </c:numCache>
              </c:numRef>
            </c:minus>
          </c:errBars>
          <c:cat>
            <c:numRef>
              <c:f>SOD_H2O2!$U$30:$U$34</c:f>
              <c:numCache>
                <c:formatCode>General</c:formatCode>
                <c:ptCount val="5"/>
              </c:numCache>
            </c:numRef>
          </c:cat>
          <c:val>
            <c:numRef>
              <c:f>SOD_H2O2!$Z$30:$Z$34</c:f>
              <c:numCache>
                <c:formatCode>###0.00;\-###0.00</c:formatCode>
                <c:ptCount val="5"/>
                <c:pt idx="0">
                  <c:v>13.899241738497851</c:v>
                </c:pt>
                <c:pt idx="1">
                  <c:v>7.4569844512511096</c:v>
                </c:pt>
                <c:pt idx="2">
                  <c:v>9.0136923890987237</c:v>
                </c:pt>
                <c:pt idx="3">
                  <c:v>10.038568257048473</c:v>
                </c:pt>
                <c:pt idx="4">
                  <c:v>10.66313081925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2048000"/>
        <c:axId val="71233472"/>
      </c:barChart>
      <c:catAx>
        <c:axId val="122048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71233472"/>
        <c:crosses val="autoZero"/>
        <c:auto val="1"/>
        <c:lblAlgn val="ctr"/>
        <c:lblOffset val="100"/>
        <c:noMultiLvlLbl val="0"/>
      </c:catAx>
      <c:valAx>
        <c:axId val="71233472"/>
        <c:scaling>
          <c:orientation val="minMax"/>
          <c:max val="2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22048000"/>
        <c:crosses val="autoZero"/>
        <c:crossBetween val="between"/>
        <c:majorUnit val="5"/>
      </c:valAx>
      <c:spPr>
        <a:noFill/>
        <a:ln w="1905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2111728395061731E-2"/>
          <c:y val="3.3120512820512822E-2"/>
          <c:w val="0.88152222222222221"/>
          <c:h val="0.858052136752136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OD_H2O2!$W$30:$W$34</c:f>
                <c:numCache>
                  <c:formatCode>General</c:formatCode>
                  <c:ptCount val="5"/>
                  <c:pt idx="0">
                    <c:v>0.46552952982290385</c:v>
                  </c:pt>
                  <c:pt idx="1">
                    <c:v>0.98556169174735753</c:v>
                  </c:pt>
                  <c:pt idx="2">
                    <c:v>0.2492301562476055</c:v>
                  </c:pt>
                  <c:pt idx="3">
                    <c:v>0.77266752902202773</c:v>
                  </c:pt>
                  <c:pt idx="4">
                    <c:v>0.64497516929029619</c:v>
                  </c:pt>
                </c:numCache>
              </c:numRef>
            </c:plus>
            <c:minus>
              <c:numRef>
                <c:f>SOD_H2O2!$W$30:$W$34</c:f>
                <c:numCache>
                  <c:formatCode>General</c:formatCode>
                  <c:ptCount val="5"/>
                  <c:pt idx="0">
                    <c:v>0.46552952982290385</c:v>
                  </c:pt>
                  <c:pt idx="1">
                    <c:v>0.98556169174735753</c:v>
                  </c:pt>
                  <c:pt idx="2">
                    <c:v>0.2492301562476055</c:v>
                  </c:pt>
                  <c:pt idx="3">
                    <c:v>0.77266752902202773</c:v>
                  </c:pt>
                  <c:pt idx="4">
                    <c:v>0.64497516929029619</c:v>
                  </c:pt>
                </c:numCache>
              </c:numRef>
            </c:minus>
          </c:errBars>
          <c:cat>
            <c:numRef>
              <c:f>SOD_H2O2!$U$30:$U$34</c:f>
              <c:numCache>
                <c:formatCode>@</c:formatCode>
                <c:ptCount val="5"/>
              </c:numCache>
            </c:numRef>
          </c:cat>
          <c:val>
            <c:numRef>
              <c:f>SOD_H2O2!$V$30:$V$34</c:f>
              <c:numCache>
                <c:formatCode>###0.00;\-###0.00</c:formatCode>
                <c:ptCount val="5"/>
                <c:pt idx="0">
                  <c:v>14.727335462191917</c:v>
                </c:pt>
                <c:pt idx="1">
                  <c:v>9.4591315533446707</c:v>
                </c:pt>
                <c:pt idx="2">
                  <c:v>8.7091956572331028</c:v>
                </c:pt>
                <c:pt idx="3">
                  <c:v>11.722703516699141</c:v>
                </c:pt>
                <c:pt idx="4">
                  <c:v>13.1642021469482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2047488"/>
        <c:axId val="71236352"/>
      </c:barChart>
      <c:catAx>
        <c:axId val="122047488"/>
        <c:scaling>
          <c:orientation val="minMax"/>
        </c:scaling>
        <c:delete val="0"/>
        <c:axPos val="b"/>
        <c:numFmt formatCode="@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71236352"/>
        <c:crosses val="autoZero"/>
        <c:auto val="1"/>
        <c:lblAlgn val="ctr"/>
        <c:lblOffset val="100"/>
        <c:noMultiLvlLbl val="0"/>
      </c:catAx>
      <c:valAx>
        <c:axId val="71236352"/>
        <c:scaling>
          <c:orientation val="minMax"/>
          <c:max val="2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22047488"/>
        <c:crosses val="autoZero"/>
        <c:crossBetween val="between"/>
        <c:majorUnit val="5"/>
      </c:valAx>
      <c:spPr>
        <a:noFill/>
        <a:ln w="1905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2111728395061731E-2"/>
          <c:y val="3.3120512820512822E-2"/>
          <c:w val="0.89347376543209878"/>
          <c:h val="0.858052136752136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OD_H2O2!$W$7:$W$11</c:f>
                <c:numCache>
                  <c:formatCode>General</c:formatCode>
                  <c:ptCount val="5"/>
                  <c:pt idx="0">
                    <c:v>0.43549959218207773</c:v>
                  </c:pt>
                  <c:pt idx="1">
                    <c:v>0.14228276922366692</c:v>
                  </c:pt>
                  <c:pt idx="2">
                    <c:v>0.35716720319145479</c:v>
                  </c:pt>
                  <c:pt idx="3">
                    <c:v>0.24261298104392215</c:v>
                  </c:pt>
                  <c:pt idx="4">
                    <c:v>8.9566827457986914E-2</c:v>
                  </c:pt>
                </c:numCache>
              </c:numRef>
            </c:plus>
            <c:minus>
              <c:numRef>
                <c:f>SOD_H2O2!$W$7:$W$11</c:f>
                <c:numCache>
                  <c:formatCode>General</c:formatCode>
                  <c:ptCount val="5"/>
                  <c:pt idx="0">
                    <c:v>0.43549959218207773</c:v>
                  </c:pt>
                  <c:pt idx="1">
                    <c:v>0.14228276922366692</c:v>
                  </c:pt>
                  <c:pt idx="2">
                    <c:v>0.35716720319145479</c:v>
                  </c:pt>
                  <c:pt idx="3">
                    <c:v>0.24261298104392215</c:v>
                  </c:pt>
                  <c:pt idx="4">
                    <c:v>8.9566827457986914E-2</c:v>
                  </c:pt>
                </c:numCache>
              </c:numRef>
            </c:minus>
          </c:errBars>
          <c:cat>
            <c:numRef>
              <c:f>SOD_H2O2!$U$7:$U$11</c:f>
              <c:numCache>
                <c:formatCode>General</c:formatCode>
                <c:ptCount val="5"/>
              </c:numCache>
            </c:numRef>
          </c:cat>
          <c:val>
            <c:numRef>
              <c:f>SOD_H2O2!$V$7:$V$11</c:f>
              <c:numCache>
                <c:formatCode>###0.00;\-###0.00</c:formatCode>
                <c:ptCount val="5"/>
                <c:pt idx="0">
                  <c:v>10.148419727887246</c:v>
                </c:pt>
                <c:pt idx="1">
                  <c:v>6.3883896226795249</c:v>
                </c:pt>
                <c:pt idx="2">
                  <c:v>6.2123576269940486</c:v>
                </c:pt>
                <c:pt idx="3">
                  <c:v>7.298820793056346</c:v>
                </c:pt>
                <c:pt idx="4">
                  <c:v>7.60880256841800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2309632"/>
        <c:axId val="122749504"/>
      </c:barChart>
      <c:catAx>
        <c:axId val="122309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22749504"/>
        <c:crosses val="autoZero"/>
        <c:auto val="1"/>
        <c:lblAlgn val="ctr"/>
        <c:lblOffset val="100"/>
        <c:noMultiLvlLbl val="0"/>
      </c:catAx>
      <c:valAx>
        <c:axId val="122749504"/>
        <c:scaling>
          <c:orientation val="minMax"/>
          <c:max val="15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22309632"/>
        <c:crosses val="autoZero"/>
        <c:crossBetween val="between"/>
        <c:majorUnit val="5"/>
      </c:valAx>
      <c:spPr>
        <a:noFill/>
        <a:ln w="1905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984876543209989E-2"/>
          <c:y val="3.3120512820512822E-2"/>
          <c:w val="0.88152222222222221"/>
          <c:h val="0.8680085470085476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OD_H2O2!$AA$7:$AA$11</c:f>
                <c:numCache>
                  <c:formatCode>General</c:formatCode>
                  <c:ptCount val="5"/>
                  <c:pt idx="0">
                    <c:v>0.98501524819856179</c:v>
                  </c:pt>
                  <c:pt idx="1">
                    <c:v>0.80991618098230445</c:v>
                  </c:pt>
                  <c:pt idx="2">
                    <c:v>0.3652571465360015</c:v>
                  </c:pt>
                  <c:pt idx="3">
                    <c:v>0.18112460150553095</c:v>
                  </c:pt>
                  <c:pt idx="4">
                    <c:v>0.25839759874173979</c:v>
                  </c:pt>
                </c:numCache>
              </c:numRef>
            </c:plus>
            <c:minus>
              <c:numRef>
                <c:f>SOD_H2O2!$AA$7:$AA$11</c:f>
                <c:numCache>
                  <c:formatCode>General</c:formatCode>
                  <c:ptCount val="5"/>
                  <c:pt idx="0">
                    <c:v>0.98501524819856179</c:v>
                  </c:pt>
                  <c:pt idx="1">
                    <c:v>0.80991618098230445</c:v>
                  </c:pt>
                  <c:pt idx="2">
                    <c:v>0.3652571465360015</c:v>
                  </c:pt>
                  <c:pt idx="3">
                    <c:v>0.18112460150553095</c:v>
                  </c:pt>
                  <c:pt idx="4">
                    <c:v>0.25839759874173979</c:v>
                  </c:pt>
                </c:numCache>
              </c:numRef>
            </c:minus>
          </c:errBars>
          <c:cat>
            <c:numRef>
              <c:f>SOD_H2O2!$U$7:$U$11</c:f>
              <c:numCache>
                <c:formatCode>General</c:formatCode>
                <c:ptCount val="5"/>
              </c:numCache>
            </c:numRef>
          </c:cat>
          <c:val>
            <c:numRef>
              <c:f>SOD_H2O2!$Z$7:$Z$11</c:f>
              <c:numCache>
                <c:formatCode>###0.00;\-###0.00</c:formatCode>
                <c:ptCount val="5"/>
                <c:pt idx="0">
                  <c:v>13.192679108854014</c:v>
                </c:pt>
                <c:pt idx="1">
                  <c:v>5.98434237967993</c:v>
                </c:pt>
                <c:pt idx="2">
                  <c:v>8.5361897631115919</c:v>
                </c:pt>
                <c:pt idx="3">
                  <c:v>10.711050092741059</c:v>
                </c:pt>
                <c:pt idx="4">
                  <c:v>12.4452203081448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2308608"/>
        <c:axId val="122750656"/>
      </c:barChart>
      <c:catAx>
        <c:axId val="122308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22750656"/>
        <c:crosses val="autoZero"/>
        <c:auto val="1"/>
        <c:lblAlgn val="ctr"/>
        <c:lblOffset val="100"/>
        <c:noMultiLvlLbl val="0"/>
      </c:catAx>
      <c:valAx>
        <c:axId val="122750656"/>
        <c:scaling>
          <c:orientation val="minMax"/>
          <c:max val="2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22308608"/>
        <c:crosses val="autoZero"/>
        <c:crossBetween val="between"/>
        <c:majorUnit val="5"/>
      </c:valAx>
      <c:spPr>
        <a:noFill/>
        <a:ln w="1905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959C29-50FD-42D3-AE1D-AD13C900E7B7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562" y="4721186"/>
            <a:ext cx="5444490" cy="44727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4939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4E8BF6-F26E-4F7E-B2C6-E59F0690B57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1018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B6EC616-DE3F-4CB3-B6B0-CC341DC5A583}" type="slidenum">
              <a:rPr lang="ko-KR" altLang="en-US" smtClean="0">
                <a:solidFill>
                  <a:prstClr val="black"/>
                </a:solidFill>
              </a:rPr>
              <a:pPr/>
              <a:t>1</a:t>
            </a:fld>
            <a:endParaRPr lang="ko-KR" alt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051B49-942F-4CC7-AE8B-F665D1FDDB7F}" type="datetimeFigureOut">
              <a:rPr lang="ko-KR" altLang="en-US" smtClean="0"/>
              <a:pPr/>
              <a:t>2016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2E2B4B-443D-420D-AC74-FC878EE55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2" name="차트 1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0405629"/>
              </p:ext>
            </p:extLst>
          </p:nvPr>
        </p:nvGraphicFramePr>
        <p:xfrm>
          <a:off x="5023368" y="2926202"/>
          <a:ext cx="324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1" name="차트 1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0186153"/>
              </p:ext>
            </p:extLst>
          </p:nvPr>
        </p:nvGraphicFramePr>
        <p:xfrm>
          <a:off x="1231166" y="2956743"/>
          <a:ext cx="324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0" name="차트 1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6729518"/>
              </p:ext>
            </p:extLst>
          </p:nvPr>
        </p:nvGraphicFramePr>
        <p:xfrm>
          <a:off x="4960524" y="432613"/>
          <a:ext cx="324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9" name="차트 1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7200498"/>
              </p:ext>
            </p:extLst>
          </p:nvPr>
        </p:nvGraphicFramePr>
        <p:xfrm>
          <a:off x="1237287" y="433146"/>
          <a:ext cx="324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128" name="그룹 127"/>
          <p:cNvGrpSpPr/>
          <p:nvPr/>
        </p:nvGrpSpPr>
        <p:grpSpPr>
          <a:xfrm>
            <a:off x="4319026" y="4741051"/>
            <a:ext cx="3777079" cy="465369"/>
            <a:chOff x="611560" y="2767450"/>
            <a:chExt cx="3777079" cy="465369"/>
          </a:xfrm>
        </p:grpSpPr>
        <p:sp>
          <p:nvSpPr>
            <p:cNvPr id="129" name="TextBox 128"/>
            <p:cNvSpPr txBox="1"/>
            <p:nvPr/>
          </p:nvSpPr>
          <p:spPr>
            <a:xfrm>
              <a:off x="1738239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1738239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2321871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2325666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289357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474177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406696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659115" y="2805311"/>
              <a:ext cx="10236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COE (µg/mL)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611560" y="2986598"/>
              <a:ext cx="1070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H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O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 </a:t>
              </a:r>
              <a:r>
                <a:rPr lang="en-US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(100 </a:t>
              </a:r>
              <a:r>
                <a:rPr lang="el-GR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μ</a:t>
              </a:r>
              <a:r>
                <a:rPr lang="en-US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M) 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2842809" y="2793088"/>
              <a:ext cx="374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430769" y="2793088"/>
              <a:ext cx="3796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3976459" y="2793088"/>
              <a:ext cx="4121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그룹 93"/>
          <p:cNvGrpSpPr/>
          <p:nvPr/>
        </p:nvGrpSpPr>
        <p:grpSpPr>
          <a:xfrm>
            <a:off x="539552" y="4741051"/>
            <a:ext cx="3777079" cy="465369"/>
            <a:chOff x="611560" y="2767450"/>
            <a:chExt cx="3777079" cy="465369"/>
          </a:xfrm>
        </p:grpSpPr>
        <p:sp>
          <p:nvSpPr>
            <p:cNvPr id="95" name="TextBox 94"/>
            <p:cNvSpPr txBox="1"/>
            <p:nvPr/>
          </p:nvSpPr>
          <p:spPr>
            <a:xfrm>
              <a:off x="1738239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738239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321871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325666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89357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474177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06696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659115" y="2805311"/>
              <a:ext cx="10236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COE (µg/mL)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611560" y="2986598"/>
              <a:ext cx="1070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H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O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 </a:t>
              </a:r>
              <a:r>
                <a:rPr lang="en-US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(100 </a:t>
              </a:r>
              <a:r>
                <a:rPr lang="el-GR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μ</a:t>
              </a:r>
              <a:r>
                <a:rPr lang="en-US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M) 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2842809" y="2793088"/>
              <a:ext cx="374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430769" y="2793088"/>
              <a:ext cx="3796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976459" y="2793088"/>
              <a:ext cx="4121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그룹 72"/>
          <p:cNvGrpSpPr/>
          <p:nvPr/>
        </p:nvGrpSpPr>
        <p:grpSpPr>
          <a:xfrm>
            <a:off x="539793" y="2233131"/>
            <a:ext cx="3777079" cy="465369"/>
            <a:chOff x="611560" y="2767450"/>
            <a:chExt cx="3777079" cy="465369"/>
          </a:xfrm>
        </p:grpSpPr>
        <p:sp>
          <p:nvSpPr>
            <p:cNvPr id="74" name="TextBox 73"/>
            <p:cNvSpPr txBox="1"/>
            <p:nvPr/>
          </p:nvSpPr>
          <p:spPr>
            <a:xfrm>
              <a:off x="1738239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738239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321871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325666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89357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474177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06696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659115" y="2805311"/>
              <a:ext cx="10236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COE (µg/mL)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611560" y="2986598"/>
              <a:ext cx="1070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H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O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 (100 </a:t>
              </a:r>
              <a:r>
                <a:rPr lang="el-GR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μ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M) 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842809" y="2793088"/>
              <a:ext cx="374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430769" y="2793088"/>
              <a:ext cx="3796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976459" y="2793088"/>
              <a:ext cx="4121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 rot="10800000">
            <a:off x="924162" y="518313"/>
            <a:ext cx="338554" cy="175503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33198" y="260648"/>
            <a:ext cx="395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037077" y="1123256"/>
            <a:ext cx="13592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493544" y="301447"/>
            <a:ext cx="400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494364" y="2743657"/>
            <a:ext cx="400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721697" y="2723888"/>
            <a:ext cx="394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6249165" y="494328"/>
            <a:ext cx="1068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SO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473745" y="2975198"/>
            <a:ext cx="1068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talas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6246296" y="2976541"/>
            <a:ext cx="1068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Px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2480718" y="503853"/>
            <a:ext cx="1068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u/Zn-SO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 rot="10800000">
            <a:off x="4695606" y="510680"/>
            <a:ext cx="338554" cy="175503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 rot="10800000">
            <a:off x="925840" y="2987338"/>
            <a:ext cx="338554" cy="175503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 rot="10800000">
            <a:off x="4695606" y="2982746"/>
            <a:ext cx="338554" cy="175503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2" name="그룹 121"/>
          <p:cNvGrpSpPr/>
          <p:nvPr/>
        </p:nvGrpSpPr>
        <p:grpSpPr>
          <a:xfrm>
            <a:off x="4303297" y="2224682"/>
            <a:ext cx="3777079" cy="465369"/>
            <a:chOff x="611560" y="2767450"/>
            <a:chExt cx="3777079" cy="465369"/>
          </a:xfrm>
        </p:grpSpPr>
        <p:sp>
          <p:nvSpPr>
            <p:cNvPr id="123" name="TextBox 122"/>
            <p:cNvSpPr txBox="1"/>
            <p:nvPr/>
          </p:nvSpPr>
          <p:spPr>
            <a:xfrm>
              <a:off x="1738239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738239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321871" y="2767450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2325666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89357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3474177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066965" y="2976954"/>
              <a:ext cx="276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659115" y="2805311"/>
              <a:ext cx="10236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COE (µg/mL)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611560" y="2986598"/>
              <a:ext cx="1070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H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O</a:t>
              </a:r>
              <a:r>
                <a:rPr lang="en-US" altLang="ko-KR" sz="1000" b="1" baseline="-250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0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 </a:t>
              </a:r>
              <a:r>
                <a:rPr lang="en-US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(100 </a:t>
              </a:r>
              <a:r>
                <a:rPr lang="el-GR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μ</a:t>
              </a:r>
              <a:r>
                <a:rPr lang="en-US" altLang="ko-KR" sz="10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M) </a:t>
              </a:r>
              <a:endParaRPr lang="ko-KR" altLang="en-US" sz="10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842809" y="2793088"/>
              <a:ext cx="374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430769" y="2793088"/>
              <a:ext cx="3796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976459" y="2793088"/>
              <a:ext cx="4121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3" name="TextBox 92"/>
          <p:cNvSpPr txBox="1"/>
          <p:nvPr/>
        </p:nvSpPr>
        <p:spPr>
          <a:xfrm>
            <a:off x="1675437" y="780333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3388153" y="1052736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3948970" y="850814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817919" y="1248978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2243664" y="1425827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5458822" y="798263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7186052" y="1138762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7764058" y="1112424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6615818" y="1241392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6041563" y="1257654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671800" y="3195856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243485" y="3595050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808524" y="3673005"/>
            <a:ext cx="229940" cy="196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293785" y="3412695"/>
            <a:ext cx="4030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858395" y="3275834"/>
            <a:ext cx="4030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5458594" y="3172070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7761412" y="3545693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7190608" y="3573419"/>
            <a:ext cx="229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6534546" y="3704095"/>
            <a:ext cx="3744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5969293" y="3829765"/>
            <a:ext cx="3744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직사각형 88"/>
          <p:cNvSpPr/>
          <p:nvPr/>
        </p:nvSpPr>
        <p:spPr>
          <a:xfrm>
            <a:off x="120853" y="5499809"/>
            <a:ext cx="885698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solidFill>
                  <a:prstClr val="black"/>
                </a:solidFill>
              </a:rPr>
              <a:t>Supplementary </a:t>
            </a:r>
            <a:r>
              <a:rPr lang="en-US" altLang="ko-KR" sz="1400" b="1" dirty="0" smtClean="0">
                <a:solidFill>
                  <a:prstClr val="black"/>
                </a:solidFill>
              </a:rPr>
              <a:t>Fig. </a:t>
            </a:r>
            <a:r>
              <a:rPr lang="en-US" altLang="ko-KR" sz="1400" b="1" dirty="0">
                <a:solidFill>
                  <a:prstClr val="black"/>
                </a:solidFill>
              </a:rPr>
              <a:t>1</a:t>
            </a:r>
            <a:r>
              <a:rPr lang="en-US" altLang="ko-KR" sz="1400" dirty="0">
                <a:solidFill>
                  <a:prstClr val="black"/>
                </a:solidFill>
              </a:rPr>
              <a:t>. </a:t>
            </a:r>
            <a:r>
              <a:rPr lang="en-US" altLang="ko-KR" sz="1400" b="1" dirty="0">
                <a:solidFill>
                  <a:prstClr val="black"/>
                </a:solidFill>
              </a:rPr>
              <a:t>Effect of </a:t>
            </a:r>
            <a:r>
              <a:rPr lang="en-US" altLang="ko-KR" sz="1400" b="1" i="1" dirty="0" err="1">
                <a:solidFill>
                  <a:prstClr val="black"/>
                </a:solidFill>
              </a:rPr>
              <a:t>Cornus</a:t>
            </a:r>
            <a:r>
              <a:rPr lang="en-US" altLang="ko-KR" sz="1400" b="1" i="1" dirty="0">
                <a:solidFill>
                  <a:prstClr val="black"/>
                </a:solidFill>
              </a:rPr>
              <a:t> officinalis </a:t>
            </a:r>
            <a:r>
              <a:rPr lang="en-US" altLang="ko-KR" sz="1400" b="1" dirty="0">
                <a:solidFill>
                  <a:prstClr val="black"/>
                </a:solidFill>
              </a:rPr>
              <a:t>extracts on the expression of antioxidant-related genes in RAW 264.7 cells. </a:t>
            </a:r>
            <a:r>
              <a:rPr lang="en-US" altLang="ko-KR" sz="1400" dirty="0"/>
              <a:t>Cells were treated </a:t>
            </a:r>
            <a:r>
              <a:rPr lang="en-US" altLang="ko-KR" sz="1400" dirty="0" smtClean="0"/>
              <a:t>with H</a:t>
            </a:r>
            <a:r>
              <a:rPr lang="en-US" altLang="ko-KR" sz="1400" baseline="-25000" dirty="0" smtClean="0"/>
              <a:t>2</a:t>
            </a:r>
            <a:r>
              <a:rPr lang="en-US" altLang="ko-KR" sz="1400" dirty="0" smtClean="0"/>
              <a:t>O</a:t>
            </a:r>
            <a:r>
              <a:rPr lang="en-US" altLang="ko-KR" sz="1400" baseline="-25000" dirty="0" smtClean="0"/>
              <a:t>2</a:t>
            </a:r>
            <a:r>
              <a:rPr lang="en-US" altLang="ko-KR" sz="1400" dirty="0" smtClean="0"/>
              <a:t> (100 </a:t>
            </a:r>
            <a:r>
              <a:rPr lang="el-GR" altLang="ko-KR" sz="1400" dirty="0" smtClean="0"/>
              <a:t>μ</a:t>
            </a:r>
            <a:r>
              <a:rPr lang="en-US" altLang="ko-KR" sz="1400" dirty="0"/>
              <a:t>M)and </a:t>
            </a:r>
            <a:r>
              <a:rPr lang="en-US" altLang="ko-KR" sz="1400" i="1" dirty="0" err="1" smtClean="0"/>
              <a:t>Cornus</a:t>
            </a:r>
            <a:r>
              <a:rPr lang="en-US" altLang="ko-KR" sz="1400" i="1" dirty="0" smtClean="0"/>
              <a:t> </a:t>
            </a:r>
            <a:r>
              <a:rPr lang="en-US" altLang="ko-KR" sz="1400" i="1" dirty="0"/>
              <a:t>officinalis</a:t>
            </a:r>
            <a:r>
              <a:rPr lang="en-US" altLang="ko-KR" sz="1400" dirty="0"/>
              <a:t> extracts at different concentrations (10, 50, and 100 </a:t>
            </a:r>
            <a:r>
              <a:rPr lang="en-US" altLang="ko-KR" sz="1400" dirty="0" err="1"/>
              <a:t>μg</a:t>
            </a:r>
            <a:r>
              <a:rPr lang="en-US" altLang="ko-KR" sz="1400" dirty="0"/>
              <a:t>/mL). Values are the mean ± SEM of experiments in triplicate. Values expressed by different letters are significantly different at </a:t>
            </a:r>
            <a:r>
              <a:rPr lang="en-US" altLang="ko-KR" sz="1400" i="1" dirty="0"/>
              <a:t>p</a:t>
            </a:r>
            <a:r>
              <a:rPr lang="en-US" altLang="ko-KR" sz="1400" dirty="0"/>
              <a:t> &lt; 0.05</a:t>
            </a:r>
            <a:r>
              <a:rPr lang="en-US" altLang="ko-KR" sz="1400" dirty="0" smtClean="0"/>
              <a:t>. </a:t>
            </a:r>
            <a:r>
              <a:rPr lang="en-US" altLang="ko-KR" sz="1400" dirty="0"/>
              <a:t>COE; </a:t>
            </a:r>
            <a:r>
              <a:rPr lang="en-US" altLang="ko-KR" sz="1400" i="1" dirty="0" err="1"/>
              <a:t>Cornus</a:t>
            </a:r>
            <a:r>
              <a:rPr lang="en-US" altLang="ko-KR" sz="1400" i="1" dirty="0"/>
              <a:t> officinalis</a:t>
            </a:r>
            <a:r>
              <a:rPr lang="en-US" altLang="ko-KR" sz="1400" dirty="0"/>
              <a:t> ethanol extracts.</a:t>
            </a:r>
            <a:endParaRPr lang="ko-KR" altLang="ko-KR" sz="14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8355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26"/>
          <p:cNvSpPr/>
          <p:nvPr/>
        </p:nvSpPr>
        <p:spPr>
          <a:xfrm>
            <a:off x="55827" y="4653136"/>
            <a:ext cx="897783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solidFill>
                  <a:prstClr val="black"/>
                </a:solidFill>
              </a:rPr>
              <a:t>Supplementary </a:t>
            </a:r>
            <a:r>
              <a:rPr lang="en-US" altLang="ko-KR" sz="1400" b="1" dirty="0" smtClean="0">
                <a:solidFill>
                  <a:prstClr val="black"/>
                </a:solidFill>
              </a:rPr>
              <a:t>Fig. 2</a:t>
            </a:r>
            <a:r>
              <a:rPr lang="en-US" altLang="ko-KR" sz="1400" dirty="0" smtClean="0">
                <a:solidFill>
                  <a:prstClr val="black"/>
                </a:solidFill>
              </a:rPr>
              <a:t>.</a:t>
            </a:r>
            <a:r>
              <a:rPr lang="en-US" altLang="ko-KR" sz="1400" b="1" dirty="0" smtClean="0"/>
              <a:t> </a:t>
            </a:r>
            <a:r>
              <a:rPr lang="en-US" altLang="ko-KR" sz="1400" b="1" dirty="0"/>
              <a:t>Effect of </a:t>
            </a:r>
            <a:r>
              <a:rPr lang="en-US" altLang="ko-KR" sz="1400" b="1" i="1" dirty="0" err="1"/>
              <a:t>Cornus</a:t>
            </a:r>
            <a:r>
              <a:rPr lang="en-US" altLang="ko-KR" sz="1400" b="1" i="1" dirty="0"/>
              <a:t> officinalis</a:t>
            </a:r>
            <a:r>
              <a:rPr lang="en-US" altLang="ko-KR" sz="1400" b="1" dirty="0"/>
              <a:t> extracts on the </a:t>
            </a:r>
            <a:r>
              <a:rPr lang="en-US" altLang="ko-KR" sz="1400" b="1" dirty="0" smtClean="0"/>
              <a:t>protein expression </a:t>
            </a:r>
            <a:r>
              <a:rPr lang="en-US" altLang="ko-KR" sz="1400" b="1" dirty="0"/>
              <a:t>of </a:t>
            </a:r>
            <a:r>
              <a:rPr lang="en-US" altLang="ko-KR" sz="1400" b="1" dirty="0" smtClean="0"/>
              <a:t>antioxidant enzymes in </a:t>
            </a:r>
            <a:r>
              <a:rPr lang="en-US" altLang="ko-KR" sz="1400" b="1" dirty="0"/>
              <a:t>RAW 264.7 cells. </a:t>
            </a:r>
            <a:r>
              <a:rPr lang="en-US" altLang="ko-KR" sz="1400" dirty="0"/>
              <a:t>Cells were treated with </a:t>
            </a:r>
            <a:r>
              <a:rPr lang="en-US" altLang="ko-KR" sz="1400" i="1" dirty="0" err="1"/>
              <a:t>Cornus</a:t>
            </a:r>
            <a:r>
              <a:rPr lang="en-US" altLang="ko-KR" sz="1400" i="1" dirty="0"/>
              <a:t> officinalis</a:t>
            </a:r>
            <a:r>
              <a:rPr lang="en-US" altLang="ko-KR" sz="1400" dirty="0"/>
              <a:t> extracts at different concentrations (10, 50, and 100 </a:t>
            </a:r>
            <a:r>
              <a:rPr lang="en-US" altLang="ko-KR" sz="1400" dirty="0" err="1"/>
              <a:t>μg</a:t>
            </a:r>
            <a:r>
              <a:rPr lang="en-US" altLang="ko-KR" sz="1400" dirty="0"/>
              <a:t>/mL). </a:t>
            </a:r>
            <a:endParaRPr lang="ko-KR" altLang="ko-KR" sz="1400" dirty="0"/>
          </a:p>
        </p:txBody>
      </p:sp>
      <p:grpSp>
        <p:nvGrpSpPr>
          <p:cNvPr id="4" name="그룹 3"/>
          <p:cNvGrpSpPr/>
          <p:nvPr/>
        </p:nvGrpSpPr>
        <p:grpSpPr>
          <a:xfrm>
            <a:off x="3130580" y="1260310"/>
            <a:ext cx="3193735" cy="2816762"/>
            <a:chOff x="3130580" y="1260310"/>
            <a:chExt cx="3193735" cy="2816762"/>
          </a:xfrm>
        </p:grpSpPr>
        <p:pic>
          <p:nvPicPr>
            <p:cNvPr id="1026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3130580" y="2403227"/>
              <a:ext cx="2016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" name="Text Box 288"/>
            <p:cNvSpPr txBox="1">
              <a:spLocks noChangeArrowheads="1"/>
            </p:cNvSpPr>
            <p:nvPr/>
          </p:nvSpPr>
          <p:spPr bwMode="auto">
            <a:xfrm>
              <a:off x="5227628" y="3819244"/>
              <a:ext cx="543976" cy="1535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l-GR" altLang="ko-KR" sz="12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en-US" altLang="ko-K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 Box 288"/>
            <p:cNvSpPr txBox="1">
              <a:spLocks noChangeArrowheads="1"/>
            </p:cNvSpPr>
            <p:nvPr/>
          </p:nvSpPr>
          <p:spPr bwMode="auto">
            <a:xfrm>
              <a:off x="5227628" y="3380243"/>
              <a:ext cx="419978" cy="1535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GPx</a:t>
              </a:r>
              <a:endParaRPr lang="en-US" altLang="ko-K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 Box 288"/>
            <p:cNvSpPr txBox="1">
              <a:spLocks noChangeArrowheads="1"/>
            </p:cNvSpPr>
            <p:nvPr/>
          </p:nvSpPr>
          <p:spPr bwMode="auto">
            <a:xfrm>
              <a:off x="5227628" y="2941239"/>
              <a:ext cx="805743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Catalase</a:t>
              </a:r>
              <a:endParaRPr lang="en-US" altLang="ko-K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 Box 288"/>
            <p:cNvSpPr txBox="1">
              <a:spLocks noChangeArrowheads="1"/>
            </p:cNvSpPr>
            <p:nvPr/>
          </p:nvSpPr>
          <p:spPr bwMode="auto">
            <a:xfrm>
              <a:off x="5227628" y="2052946"/>
              <a:ext cx="109377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Cu/</a:t>
              </a:r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ZnSOD</a:t>
              </a:r>
              <a:endParaRPr lang="en-US" altLang="ko-KR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" name="Picture 6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-25000"/>
                      </a14:imgEffect>
                      <a14:imgEffect>
                        <a14:brightnessContrast brigh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840" y="1965279"/>
              <a:ext cx="201474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" name="Picture 12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840" y="2841175"/>
              <a:ext cx="201474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1" name="Picture 13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840" y="3279123"/>
              <a:ext cx="201474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2" name="Picture 16"/>
            <p:cNvPicPr preferRelativeResize="0">
              <a:picLocks noChangeArrowheads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840" y="3717072"/>
              <a:ext cx="201474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grpSp>
          <p:nvGrpSpPr>
            <p:cNvPr id="13" name="그룹 92"/>
            <p:cNvGrpSpPr/>
            <p:nvPr/>
          </p:nvGrpSpPr>
          <p:grpSpPr>
            <a:xfrm>
              <a:off x="3223074" y="1260310"/>
              <a:ext cx="2165136" cy="468964"/>
              <a:chOff x="6854978" y="1243309"/>
              <a:chExt cx="2514676" cy="533881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7002935" y="1243309"/>
                <a:ext cx="2366719" cy="3153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. </a:t>
                </a:r>
                <a:r>
                  <a:rPr lang="en-US" altLang="ko-KR" sz="12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fficinalis </a:t>
                </a:r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lang="el-GR" altLang="ko-KR" sz="1200" b="1" dirty="0" smtClean="0">
                    <a:latin typeface="Arial" pitchFamily="34" charset="0"/>
                    <a:cs typeface="Arial" pitchFamily="34" charset="0"/>
                  </a:rPr>
                  <a:t>μ</a:t>
                </a:r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g/</a:t>
                </a:r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mL</a:t>
                </a:r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7677548" y="1525190"/>
                <a:ext cx="360040" cy="25200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1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8088833" y="1525190"/>
                <a:ext cx="360040" cy="25200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5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8533168" y="1525190"/>
                <a:ext cx="360040" cy="25200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7266263" y="1525190"/>
                <a:ext cx="360040" cy="25200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5" name="직선 연결선 24"/>
              <p:cNvCxnSpPr/>
              <p:nvPr/>
            </p:nvCxnSpPr>
            <p:spPr>
              <a:xfrm flipV="1">
                <a:off x="7328926" y="1487261"/>
                <a:ext cx="158885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/>
              <p:cNvSpPr txBox="1"/>
              <p:nvPr/>
            </p:nvSpPr>
            <p:spPr>
              <a:xfrm>
                <a:off x="6854978" y="1525190"/>
                <a:ext cx="360040" cy="25200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3629848" y="1683092"/>
              <a:ext cx="192361" cy="234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983522" y="1683092"/>
              <a:ext cx="192361" cy="234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42176" y="1683092"/>
              <a:ext cx="192361" cy="234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730020" y="1683092"/>
              <a:ext cx="192361" cy="234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281892" y="1683092"/>
              <a:ext cx="192361" cy="234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 Box 288"/>
            <p:cNvSpPr txBox="1">
              <a:spLocks noChangeArrowheads="1"/>
            </p:cNvSpPr>
            <p:nvPr/>
          </p:nvSpPr>
          <p:spPr bwMode="auto">
            <a:xfrm>
              <a:off x="5230540" y="1707836"/>
              <a:ext cx="109377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H</a:t>
              </a:r>
              <a:r>
                <a:rPr lang="en-US" altLang="ko-KR" sz="1200" b="1" baseline="-25000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2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O</a:t>
              </a:r>
              <a:r>
                <a:rPr lang="en-US" altLang="ko-KR" sz="1200" b="1" baseline="-25000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</a:t>
              </a:r>
              <a:r>
                <a:rPr lang="en-US" altLang="ko-KR" sz="12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 (100 </a:t>
              </a:r>
              <a:r>
                <a:rPr lang="el-GR" altLang="ko-KR" sz="12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μ</a:t>
              </a:r>
              <a:r>
                <a:rPr lang="en-US" altLang="ko-KR" sz="1200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M) </a:t>
              </a:r>
              <a:endParaRPr lang="ko-KR" altLang="en-US" sz="12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9" name="Text Box 288"/>
            <p:cNvSpPr txBox="1">
              <a:spLocks noChangeArrowheads="1"/>
            </p:cNvSpPr>
            <p:nvPr/>
          </p:nvSpPr>
          <p:spPr bwMode="auto">
            <a:xfrm>
              <a:off x="5227628" y="2494081"/>
              <a:ext cx="109377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MnSOD</a:t>
              </a:r>
              <a:endParaRPr lang="en-US" altLang="ko-KR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31110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851</TotalTime>
  <Words>276</Words>
  <Application>Microsoft Office PowerPoint</Application>
  <PresentationFormat>화면 슬라이드 쇼(4:3)</PresentationFormat>
  <Paragraphs>101</Paragraphs>
  <Slides>2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산수유 메탄올 추출물의 항산화 활성 및 항산화 효소의 mRNA 발현에 대한 효과</dc:title>
  <dc:creator>곽미진(210)</dc:creator>
  <cp:lastModifiedBy>ashley</cp:lastModifiedBy>
  <cp:revision>108</cp:revision>
  <dcterms:created xsi:type="dcterms:W3CDTF">2015-08-06T08:25:14Z</dcterms:created>
  <dcterms:modified xsi:type="dcterms:W3CDTF">2016-03-01T18:55:20Z</dcterms:modified>
</cp:coreProperties>
</file>